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4" d="100"/>
          <a:sy n="104" d="100"/>
        </p:scale>
        <p:origin x="-222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F8EC9F-7D68-49B8-A7DC-B049251E2A57}" type="datetimeFigureOut">
              <a:rPr lang="en-GB" smtClean="0"/>
              <a:pPr/>
              <a:t>12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BD7FD4-E55B-4828-9F4F-633B3EFEA0C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6692870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F8EC9F-7D68-49B8-A7DC-B049251E2A57}" type="datetimeFigureOut">
              <a:rPr lang="en-GB" smtClean="0"/>
              <a:pPr/>
              <a:t>12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BD7FD4-E55B-4828-9F4F-633B3EFEA0C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7117102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F8EC9F-7D68-49B8-A7DC-B049251E2A57}" type="datetimeFigureOut">
              <a:rPr lang="en-GB" smtClean="0"/>
              <a:pPr/>
              <a:t>12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BD7FD4-E55B-4828-9F4F-633B3EFEA0C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41702467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F8EC9F-7D68-49B8-A7DC-B049251E2A57}" type="datetimeFigureOut">
              <a:rPr lang="en-GB" smtClean="0"/>
              <a:pPr/>
              <a:t>12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BD7FD4-E55B-4828-9F4F-633B3EFEA0C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6653174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F8EC9F-7D68-49B8-A7DC-B049251E2A57}" type="datetimeFigureOut">
              <a:rPr lang="en-GB" smtClean="0"/>
              <a:pPr/>
              <a:t>12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BD7FD4-E55B-4828-9F4F-633B3EFEA0C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8093297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F8EC9F-7D68-49B8-A7DC-B049251E2A57}" type="datetimeFigureOut">
              <a:rPr lang="en-GB" smtClean="0"/>
              <a:pPr/>
              <a:t>12/06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BD7FD4-E55B-4828-9F4F-633B3EFEA0C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3319025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F8EC9F-7D68-49B8-A7DC-B049251E2A57}" type="datetimeFigureOut">
              <a:rPr lang="en-GB" smtClean="0"/>
              <a:pPr/>
              <a:t>12/06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BD7FD4-E55B-4828-9F4F-633B3EFEA0C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22089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F8EC9F-7D68-49B8-A7DC-B049251E2A57}" type="datetimeFigureOut">
              <a:rPr lang="en-GB" smtClean="0"/>
              <a:pPr/>
              <a:t>12/06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BD7FD4-E55B-4828-9F4F-633B3EFEA0C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4193925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F8EC9F-7D68-49B8-A7DC-B049251E2A57}" type="datetimeFigureOut">
              <a:rPr lang="en-GB" smtClean="0"/>
              <a:pPr/>
              <a:t>12/06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BD7FD4-E55B-4828-9F4F-633B3EFEA0C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5067096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F8EC9F-7D68-49B8-A7DC-B049251E2A57}" type="datetimeFigureOut">
              <a:rPr lang="en-GB" smtClean="0"/>
              <a:pPr/>
              <a:t>12/06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BD7FD4-E55B-4828-9F4F-633B3EFEA0C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280173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F8EC9F-7D68-49B8-A7DC-B049251E2A57}" type="datetimeFigureOut">
              <a:rPr lang="en-GB" smtClean="0"/>
              <a:pPr/>
              <a:t>12/06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BD7FD4-E55B-4828-9F4F-633B3EFEA0C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9373209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F8EC9F-7D68-49B8-A7DC-B049251E2A57}" type="datetimeFigureOut">
              <a:rPr lang="en-GB" smtClean="0"/>
              <a:pPr/>
              <a:t>12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BD7FD4-E55B-4828-9F4F-633B3EFEA0C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4636624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72537" y="404664"/>
            <a:ext cx="806489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/>
              <a:t>Contralateral dissociation between neural activity and cerebral blood volume during recurrent acute neocortical seizures</a:t>
            </a:r>
            <a:endParaRPr lang="en-GB" b="1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139952" y="2213067"/>
            <a:ext cx="4572001" cy="258068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572537" y="1988840"/>
            <a:ext cx="3495407" cy="3293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1600" dirty="0" smtClean="0"/>
              <a:t>Whether epileptic events disrupt normal neurovascular coupling mechanisms locally or remotely is unclear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GB" sz="1600" dirty="0" smtClean="0"/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1600" dirty="0" smtClean="0"/>
              <a:t>Here, we show non-linear neurovascular coupling in the seizure onset zone and a dissociation between neural activity and cerebral blood volume in contralateral cortex during recurrent acute (4-aminopyridine) seizures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GB" sz="1600" dirty="0"/>
          </a:p>
        </p:txBody>
      </p:sp>
      <p:cxnSp>
        <p:nvCxnSpPr>
          <p:cNvPr id="9" name="Straight Connector 8"/>
          <p:cNvCxnSpPr/>
          <p:nvPr/>
        </p:nvCxnSpPr>
        <p:spPr>
          <a:xfrm>
            <a:off x="860569" y="1050995"/>
            <a:ext cx="748883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" name="Picture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79512" y="6337069"/>
            <a:ext cx="9144000" cy="520931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195736" y="6337068"/>
            <a:ext cx="39604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Harris et al, 2014</a:t>
            </a:r>
            <a:r>
              <a:rPr lang="en-US" sz="1400" dirty="0" smtClean="0"/>
              <a:t>, DOI: </a:t>
            </a:r>
            <a:r>
              <a:rPr lang="en-US" sz="1400" dirty="0" smtClean="0"/>
              <a:t>10.1111/</a:t>
            </a:r>
            <a:r>
              <a:rPr lang="en-US" sz="1400" dirty="0" err="1" smtClean="0"/>
              <a:t>epi.12726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xmlns="" val="24493257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70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m Harris</dc:creator>
  <cp:lastModifiedBy>0009067</cp:lastModifiedBy>
  <cp:revision>6</cp:revision>
  <dcterms:created xsi:type="dcterms:W3CDTF">2014-06-09T16:25:46Z</dcterms:created>
  <dcterms:modified xsi:type="dcterms:W3CDTF">2014-06-12T04:00:24Z</dcterms:modified>
  <cp:contentStatus>Final</cp:contentStatus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MarkAsFinal">
    <vt:bool>true</vt:bool>
  </property>
</Properties>
</file>